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874" r:id="rId2"/>
    <p:sldId id="878" r:id="rId3"/>
    <p:sldId id="88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ima Nasrah" initials="RN" lastIdx="2" clrIdx="0">
    <p:extLst>
      <p:ext uri="{19B8F6BF-5375-455C-9EA6-DF929625EA0E}">
        <p15:presenceInfo xmlns:p15="http://schemas.microsoft.com/office/powerpoint/2012/main" userId="Rima Nasrah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87967"/>
    <a:srgbClr val="64DAE8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617" autoAdjust="0"/>
    <p:restoredTop sz="91615"/>
  </p:normalViewPr>
  <p:slideViewPr>
    <p:cSldViewPr snapToGrid="0">
      <p:cViewPr varScale="1">
        <p:scale>
          <a:sx n="103" d="100"/>
          <a:sy n="103" d="100"/>
        </p:scale>
        <p:origin x="198" y="12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894BA4-DD83-EF4E-8B93-170C46221C0E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FBD928-6E34-104E-9E09-B644AC128A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4819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E08C61-FF1D-B594-DEC7-D8CD66A578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6F7590E6-8E25-655C-AAA8-724649052C7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54EB792-8903-9242-F8B4-CC935370D16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A4F5E8-9059-37E7-CE8D-F4A761D9512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FBD928-6E34-104E-9E09-B644AC128A8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283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C876CF-0664-CA8B-DD00-3E86F8E60FC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CD04F36C-ED42-5896-8F75-8C461A72552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9820ECD7-0B27-8A50-7269-C030676F802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C00689-11A6-1444-7444-6559A038216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FBD928-6E34-104E-9E09-B644AC128A8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5021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A43B4-02B0-618D-0792-E0B7A67452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9C9CAE-6886-9028-7E06-835FEDF7A4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28BDB0-EC95-0BFB-87B3-491A75C87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A85705-220E-9BDD-9127-D63A2040A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C2E882-E698-4EE1-E269-9370AFCBF4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677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3FFCCC-A9B5-C2F4-7CCD-C4056B8276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8B6565-AE5F-9D53-F90F-F70307A4B1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270A33-4145-C441-1455-42A5468EBD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672266-25E6-34B5-9B3B-762026F563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446413-5453-8EDA-8644-02A1D49CC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417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5F925B-19ED-6A4E-4F7D-649F7D15D6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1E2DCC-78DC-FCEB-F013-09B98B62F8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D5F677-ECA3-DFD4-E413-95383CD9F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600C38-4113-2E81-319B-663AE0C50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3F00D5-0BD4-D145-D801-5C1E45854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817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458462-5000-AEBE-1B4A-9F5FF349AC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09CBA9-4D2C-BC51-071E-554AA18D56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522138-C6E5-F312-F968-EB504AB80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AC6416-9A26-F8BB-4927-30845F7CE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3C5EE4-EDCA-5818-500D-3A582FB7B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993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97D238-6F9C-B990-E065-D1D53B8108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EC2E06-1CB4-1B65-E432-C4AE0CF240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CF2098-E587-A7FD-E624-3290E3D4D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51CD6B-9897-2F89-7EE5-394E433B4F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B572E3-A91D-8075-C1E4-7ABF6C2AA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250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45B1F2-069E-0920-6933-FF7EE2891B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BA103C-C723-2864-EEDD-455F0A0257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0C3E89-E709-A83A-D5A6-933CC63BC1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449F90-C1AD-132D-BBF2-2A1D3171C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3F9ED8-DF9E-1C07-0284-379709AC8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A7E6E1-AF31-1EC7-8C54-21C5BE59F7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15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7BF53-434E-579D-231E-CA90DD4695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259AA5-E6E9-624E-61AA-69B40C1C3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803DA4-AE94-975D-FEAB-AE14F2A3B5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5C1072-528A-4756-2235-D5BD2FC727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93E3D0C-B4D5-2AA4-C512-9511D2D2A4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ED596B6-47D8-2BDA-61C9-A9AC219857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D36545-D1E3-7F9A-7FC5-056D82BE2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B15275-BB36-4B14-64ED-0A6A1641E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911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D622BF-51AC-1177-40F5-F866F7456F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CD2C45-61E3-29EA-A4E6-EE413FE9D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6CA2A9-D6C7-AA6F-D27B-5C4565C86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49A6DE7-5E7C-B44A-A9BB-F2EF1AD4A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854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F382F7-90DF-9B15-7534-98572F7CF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4CBB5F-34BF-225C-91D0-273D9F46B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FD8ED5-4F56-9495-B2D9-35F67D921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865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1678D4-5A33-DCE0-87DD-304E1D83AC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AF8F8F-1753-0CD9-577B-567439F2B6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FD1155-7931-71F4-25AA-1EFFCE47C9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A64DF4-85B0-E72E-4E05-D7D5A8BD9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6C56AA-42B9-6E36-4F42-BD72C85A5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B13CB0-1A44-5720-DD8B-968B67C1B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390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432558-3D8C-04BD-FA1D-535F87D49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72233A2-79F9-7EC7-C968-1FDDB58205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4B1421-3782-91C7-4FF0-C294376940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C935DB-C123-BC53-480B-BC6C2E286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0B197E-A863-E37D-9ABE-6A21929D2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DC66BA-CFA2-AFFD-7634-DC9CB9FA6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719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B17D4A-26B5-F450-E4C7-B8E82B432C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6CEA01-173E-8AFD-A299-5814187FF5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8F34F6-73D5-409A-2D4F-CF5E2ABC36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D364A-8358-C84B-93D6-09CAA6C11395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4770E3-EC36-E8B6-2214-65410A4C1F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BB2647-9148-2AC4-EA1A-E1AC8A4703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4005A3-6AF1-144D-9622-6DF9B02F7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621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DBB5C3F-2169-AD43-5CF5-47B1C5F8387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3A5C807-BC68-60FF-A292-2D0046150C78}"/>
              </a:ext>
            </a:extLst>
          </p:cNvPr>
          <p:cNvSpPr txBox="1"/>
          <p:nvPr/>
        </p:nvSpPr>
        <p:spPr>
          <a:xfrm>
            <a:off x="-53013" y="-21904"/>
            <a:ext cx="35677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Figure S1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9FA1C5E-C560-5403-1DC1-201C3668961D}"/>
              </a:ext>
            </a:extLst>
          </p:cNvPr>
          <p:cNvGrpSpPr/>
          <p:nvPr/>
        </p:nvGrpSpPr>
        <p:grpSpPr>
          <a:xfrm>
            <a:off x="-5777233" y="573650"/>
            <a:ext cx="12170495" cy="5307743"/>
            <a:chOff x="527277" y="858606"/>
            <a:chExt cx="11592398" cy="5307743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1C534A5-FD88-5F20-B476-3766900E90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7411" b="7182"/>
            <a:stretch/>
          </p:blipFill>
          <p:spPr>
            <a:xfrm>
              <a:off x="6125790" y="1336872"/>
              <a:ext cx="5993885" cy="451800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688E42C-7EF9-778D-A16A-F6D4E214E681}"/>
                </a:ext>
              </a:extLst>
            </p:cNvPr>
            <p:cNvSpPr txBox="1"/>
            <p:nvPr/>
          </p:nvSpPr>
          <p:spPr>
            <a:xfrm rot="16200000">
              <a:off x="4356344" y="3365715"/>
              <a:ext cx="4465906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2400" i="1" dirty="0"/>
                <a:t>Veillonella</a:t>
              </a:r>
              <a:r>
                <a:rPr lang="en-CA" sz="2400" dirty="0"/>
                <a:t> g. counts</a:t>
              </a:r>
              <a:endParaRPr lang="en-US" sz="24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5F88E31-4B53-FDA2-2698-C9BAD21CEF9F}"/>
                </a:ext>
              </a:extLst>
            </p:cNvPr>
            <p:cNvSpPr txBox="1"/>
            <p:nvPr/>
          </p:nvSpPr>
          <p:spPr>
            <a:xfrm>
              <a:off x="8653552" y="5704684"/>
              <a:ext cx="94136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WSG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A870008-2454-7750-3073-33A5364FFB97}"/>
                </a:ext>
              </a:extLst>
            </p:cNvPr>
            <p:cNvSpPr txBox="1"/>
            <p:nvPr/>
          </p:nvSpPr>
          <p:spPr>
            <a:xfrm>
              <a:off x="10501114" y="5704684"/>
              <a:ext cx="94136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WL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0B03E6AA-3622-3760-FE70-341A12D971BE}"/>
                </a:ext>
              </a:extLst>
            </p:cNvPr>
            <p:cNvSpPr/>
            <p:nvPr/>
          </p:nvSpPr>
          <p:spPr>
            <a:xfrm>
              <a:off x="527277" y="858606"/>
              <a:ext cx="461665" cy="64799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837FA59A-C593-1AD1-FA3C-311CB7F53D16}"/>
                </a:ext>
              </a:extLst>
            </p:cNvPr>
            <p:cNvSpPr/>
            <p:nvPr/>
          </p:nvSpPr>
          <p:spPr>
            <a:xfrm>
              <a:off x="7016979" y="1024897"/>
              <a:ext cx="389712" cy="64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638728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EA3C749-9893-F61C-1D68-8B65E5AD4AA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1A36A02-5FA2-F5DC-6FFB-054BD53EF321}"/>
              </a:ext>
            </a:extLst>
          </p:cNvPr>
          <p:cNvGrpSpPr/>
          <p:nvPr/>
        </p:nvGrpSpPr>
        <p:grpSpPr>
          <a:xfrm>
            <a:off x="1330036" y="59472"/>
            <a:ext cx="10784497" cy="6733211"/>
            <a:chOff x="1330036" y="59472"/>
            <a:chExt cx="10784497" cy="6733211"/>
          </a:xfrm>
        </p:grpSpPr>
        <p:sp>
          <p:nvSpPr>
            <p:cNvPr id="5" name="AutoShape 4">
              <a:extLst>
                <a:ext uri="{FF2B5EF4-FFF2-40B4-BE49-F238E27FC236}">
                  <a16:creationId xmlns:a16="http://schemas.microsoft.com/office/drawing/2014/main" id="{9C2F415E-3AA3-7537-BBD2-455B49CF2C55}"/>
                </a:ext>
              </a:extLst>
            </p:cNvPr>
            <p:cNvSpPr>
              <a:spLocks noChangeAspect="1" noChangeArrowheads="1"/>
            </p:cNvSpPr>
            <p:nvPr/>
          </p:nvSpPr>
          <p:spPr bwMode="auto">
            <a:xfrm>
              <a:off x="5943600" y="3276600"/>
              <a:ext cx="304800" cy="3048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39697C6-C96F-474D-F031-42A9CC6BE7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316" r="7740"/>
            <a:stretch/>
          </p:blipFill>
          <p:spPr>
            <a:xfrm rot="5400000">
              <a:off x="3302185" y="-1804209"/>
              <a:ext cx="6434255" cy="10161617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E047DAF-0550-CE2F-16C7-EF29F1B052B4}"/>
                </a:ext>
              </a:extLst>
            </p:cNvPr>
            <p:cNvSpPr txBox="1"/>
            <p:nvPr/>
          </p:nvSpPr>
          <p:spPr>
            <a:xfrm>
              <a:off x="6519313" y="6331018"/>
              <a:ext cx="3844061" cy="461665"/>
            </a:xfrm>
            <a:prstGeom prst="rect">
              <a:avLst/>
            </a:prstGeom>
            <a:solidFill>
              <a:srgbClr val="E87967"/>
            </a:solidFill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WSG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12907E4-091F-CD07-9CF8-5974A00102B8}"/>
                </a:ext>
              </a:extLst>
            </p:cNvPr>
            <p:cNvSpPr txBox="1"/>
            <p:nvPr/>
          </p:nvSpPr>
          <p:spPr>
            <a:xfrm>
              <a:off x="5480536" y="6330051"/>
              <a:ext cx="1038777" cy="461665"/>
            </a:xfrm>
            <a:prstGeom prst="rect">
              <a:avLst/>
            </a:prstGeom>
            <a:solidFill>
              <a:srgbClr val="64DAE8"/>
            </a:solidFill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WL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D995731F-C6AD-26EC-85FC-B578171CDCD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19313" y="59472"/>
              <a:ext cx="4213" cy="6336863"/>
            </a:xfrm>
            <a:prstGeom prst="line">
              <a:avLst/>
            </a:prstGeom>
            <a:ln w="28575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" name="Picture 19" descr="A screenshot of a graph&#10;&#10;Description automatically generated">
              <a:extLst>
                <a:ext uri="{FF2B5EF4-FFF2-40B4-BE49-F238E27FC236}">
                  <a16:creationId xmlns:a16="http://schemas.microsoft.com/office/drawing/2014/main" id="{0A018DE6-0447-3D20-2C50-DFE8344EA8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28075"/>
            <a:stretch/>
          </p:blipFill>
          <p:spPr>
            <a:xfrm>
              <a:off x="11106405" y="2478156"/>
              <a:ext cx="1008128" cy="1947241"/>
            </a:xfrm>
            <a:prstGeom prst="rect">
              <a:avLst/>
            </a:prstGeom>
          </p:spPr>
        </p:pic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9FB254E8-D44D-CAF5-69DB-76F57CF0D6C6}"/>
                </a:ext>
              </a:extLst>
            </p:cNvPr>
            <p:cNvCxnSpPr>
              <a:cxnSpLocks/>
            </p:cNvCxnSpPr>
            <p:nvPr/>
          </p:nvCxnSpPr>
          <p:spPr>
            <a:xfrm>
              <a:off x="1438504" y="1450235"/>
              <a:ext cx="748642" cy="0"/>
            </a:xfrm>
            <a:prstGeom prst="straightConnector1">
              <a:avLst/>
            </a:prstGeom>
            <a:ln w="44450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4E644263-83B1-519B-1057-21E665943748}"/>
                </a:ext>
              </a:extLst>
            </p:cNvPr>
            <p:cNvCxnSpPr>
              <a:cxnSpLocks/>
            </p:cNvCxnSpPr>
            <p:nvPr/>
          </p:nvCxnSpPr>
          <p:spPr>
            <a:xfrm>
              <a:off x="1330036" y="6120714"/>
              <a:ext cx="1141315" cy="0"/>
            </a:xfrm>
            <a:prstGeom prst="straightConnector1">
              <a:avLst/>
            </a:prstGeom>
            <a:ln w="4445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7EC4161D-819B-38EE-94C8-33FF530FEC13}"/>
              </a:ext>
            </a:extLst>
          </p:cNvPr>
          <p:cNvSpPr txBox="1"/>
          <p:nvPr/>
        </p:nvSpPr>
        <p:spPr>
          <a:xfrm>
            <a:off x="-13855" y="1191742"/>
            <a:ext cx="15264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Lachnospira</a:t>
            </a:r>
            <a:r>
              <a:rPr lang="en-US" dirty="0"/>
              <a:t> g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585FC8B-2177-7A75-6478-CB91956C43DB}"/>
              </a:ext>
            </a:extLst>
          </p:cNvPr>
          <p:cNvSpPr txBox="1"/>
          <p:nvPr/>
        </p:nvSpPr>
        <p:spPr>
          <a:xfrm>
            <a:off x="36956" y="5874082"/>
            <a:ext cx="1373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/>
              <a:t>Veillonella</a:t>
            </a:r>
            <a:r>
              <a:rPr lang="en-US" dirty="0"/>
              <a:t> g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9770731-B819-C8A2-BF21-8C117CF6580C}"/>
              </a:ext>
            </a:extLst>
          </p:cNvPr>
          <p:cNvSpPr txBox="1"/>
          <p:nvPr/>
        </p:nvSpPr>
        <p:spPr>
          <a:xfrm>
            <a:off x="-20100" y="-57531"/>
            <a:ext cx="35677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40993763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56C7D82-DAD3-5B92-2710-6EAC45F170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124" y="1117495"/>
            <a:ext cx="5704603" cy="495666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740A4B6-A289-F201-FB81-EC666FA6622B}"/>
              </a:ext>
            </a:extLst>
          </p:cNvPr>
          <p:cNvSpPr txBox="1"/>
          <p:nvPr/>
        </p:nvSpPr>
        <p:spPr>
          <a:xfrm>
            <a:off x="-53013" y="-21904"/>
            <a:ext cx="35677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403019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02</TotalTime>
  <Words>22</Words>
  <Application>Microsoft Office PowerPoint</Application>
  <PresentationFormat>Widescreen</PresentationFormat>
  <Paragraphs>12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 Nasrah</dc:creator>
  <cp:lastModifiedBy>Rowielyn Agustin</cp:lastModifiedBy>
  <cp:revision>152</cp:revision>
  <dcterms:created xsi:type="dcterms:W3CDTF">2023-05-15T14:32:20Z</dcterms:created>
  <dcterms:modified xsi:type="dcterms:W3CDTF">2025-04-02T17:25:14Z</dcterms:modified>
</cp:coreProperties>
</file>